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575945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0" d="100"/>
          <a:sy n="400" d="100"/>
        </p:scale>
        <p:origin x="-7094" y="-22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59" y="1767462"/>
            <a:ext cx="4895533" cy="375991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5672376"/>
            <a:ext cx="4319588" cy="2607442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9958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0408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574987"/>
            <a:ext cx="1241881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3" y="574987"/>
            <a:ext cx="3653651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9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60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2692444"/>
            <a:ext cx="4967526" cy="4492401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7227345"/>
            <a:ext cx="4967526" cy="2362447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>
                    <a:tint val="82000"/>
                  </a:schemeClr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82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82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82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82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82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521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2874937"/>
            <a:ext cx="2447766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2874937"/>
            <a:ext cx="2447766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087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574990"/>
            <a:ext cx="4967526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2647443"/>
            <a:ext cx="2436517" cy="1297471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3944914"/>
            <a:ext cx="2436517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2647443"/>
            <a:ext cx="2448516" cy="1297471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3944914"/>
            <a:ext cx="2448516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6086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9778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8931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719984"/>
            <a:ext cx="1857573" cy="2519945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1554968"/>
            <a:ext cx="2915722" cy="7674832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3239929"/>
            <a:ext cx="1857573" cy="6002369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769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719984"/>
            <a:ext cx="1857573" cy="2519945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1554968"/>
            <a:ext cx="2915722" cy="7674832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3239929"/>
            <a:ext cx="1857573" cy="6002369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8984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574990"/>
            <a:ext cx="4967526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2874937"/>
            <a:ext cx="4967526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10009783"/>
            <a:ext cx="129587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DB6CC6-1877-4863-A528-2131F426D8AB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10009783"/>
            <a:ext cx="194381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10009783"/>
            <a:ext cx="129587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F1426D-E587-4FE0-B295-CAF15165F2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3745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254C664B-0B5C-0D7A-554B-B91AF4E08434}"/>
              </a:ext>
            </a:extLst>
          </p:cNvPr>
          <p:cNvGrpSpPr/>
          <p:nvPr/>
        </p:nvGrpSpPr>
        <p:grpSpPr>
          <a:xfrm>
            <a:off x="366505" y="423578"/>
            <a:ext cx="5026439" cy="9952606"/>
            <a:chOff x="2659807" y="-1223516"/>
            <a:chExt cx="5026439" cy="9952606"/>
          </a:xfrm>
        </p:grpSpPr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D76B3B07-FAD1-776D-B7F4-E5395DE48EEC}"/>
                </a:ext>
              </a:extLst>
            </p:cNvPr>
            <p:cNvGrpSpPr/>
            <p:nvPr/>
          </p:nvGrpSpPr>
          <p:grpSpPr>
            <a:xfrm>
              <a:off x="2822672" y="-1058194"/>
              <a:ext cx="4863574" cy="9787284"/>
              <a:chOff x="2822672" y="-1058194"/>
              <a:chExt cx="4863574" cy="9787284"/>
            </a:xfrm>
          </p:grpSpPr>
          <p:pic>
            <p:nvPicPr>
              <p:cNvPr id="24" name="图片 23" descr="图表, 条形图&#10;&#10;描述已自动生成">
                <a:extLst>
                  <a:ext uri="{FF2B5EF4-FFF2-40B4-BE49-F238E27FC236}">
                    <a16:creationId xmlns:a16="http://schemas.microsoft.com/office/drawing/2014/main" id="{F09C0E14-4892-D08E-3E8F-86FCFABE93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2672" y="-796584"/>
                <a:ext cx="4863573" cy="2091664"/>
              </a:xfrm>
              <a:prstGeom prst="rect">
                <a:avLst/>
              </a:prstGeom>
            </p:spPr>
          </p:pic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A83D9954-21F2-291D-75FD-053A08A15E1B}"/>
                  </a:ext>
                </a:extLst>
              </p:cNvPr>
              <p:cNvSpPr txBox="1"/>
              <p:nvPr/>
            </p:nvSpPr>
            <p:spPr>
              <a:xfrm>
                <a:off x="4394172" y="-1058194"/>
                <a:ext cx="154670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ase 1: BM-CITE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图片 25" descr="图表, 条形图&#10;&#10;描述已自动生成">
                <a:extLst>
                  <a:ext uri="{FF2B5EF4-FFF2-40B4-BE49-F238E27FC236}">
                    <a16:creationId xmlns:a16="http://schemas.microsoft.com/office/drawing/2014/main" id="{4AE48BE2-4CBA-384E-F4B7-494C1005AC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2672" y="1713216"/>
                <a:ext cx="4863574" cy="2091664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3B4372B6-CA16-9B3E-242B-DF44883D2577}"/>
                  </a:ext>
                </a:extLst>
              </p:cNvPr>
              <p:cNvSpPr txBox="1"/>
              <p:nvPr/>
            </p:nvSpPr>
            <p:spPr>
              <a:xfrm>
                <a:off x="4265959" y="1434903"/>
                <a:ext cx="18031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ase 1: PBMC-Mult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 descr="图表, 条形图&#10;&#10;描述已自动生成">
                <a:extLst>
                  <a:ext uri="{FF2B5EF4-FFF2-40B4-BE49-F238E27FC236}">
                    <a16:creationId xmlns:a16="http://schemas.microsoft.com/office/drawing/2014/main" id="{A2DF9DE5-7CE3-BFA4-15A8-14ED22BB7E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2672" y="4158068"/>
                <a:ext cx="4863574" cy="2091664"/>
              </a:xfrm>
              <a:prstGeom prst="rect">
                <a:avLst/>
              </a:prstGeom>
            </p:spPr>
          </p:pic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F48B632A-E301-D659-51D7-368EF2FBEA0F}"/>
                  </a:ext>
                </a:extLst>
              </p:cNvPr>
              <p:cNvSpPr txBox="1"/>
              <p:nvPr/>
            </p:nvSpPr>
            <p:spPr>
              <a:xfrm>
                <a:off x="4240201" y="3886883"/>
                <a:ext cx="18031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ase 2: CITE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图片 29" descr="图表, 条形图&#10;&#10;描述已自动生成">
                <a:extLst>
                  <a:ext uri="{FF2B5EF4-FFF2-40B4-BE49-F238E27FC236}">
                    <a16:creationId xmlns:a16="http://schemas.microsoft.com/office/drawing/2014/main" id="{5B8ACA9B-5D38-4D88-176E-03A7FC80CB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2672" y="6637426"/>
                <a:ext cx="4863574" cy="2091664"/>
              </a:xfrm>
              <a:prstGeom prst="rect">
                <a:avLst/>
              </a:prstGeom>
            </p:spPr>
          </p:pic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3AA87F9D-AEAC-8ABA-4B6C-0580470C677E}"/>
                  </a:ext>
                </a:extLst>
              </p:cNvPr>
              <p:cNvSpPr txBox="1"/>
              <p:nvPr/>
            </p:nvSpPr>
            <p:spPr>
              <a:xfrm>
                <a:off x="4201564" y="6364740"/>
                <a:ext cx="18031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ase 2: </a:t>
                </a:r>
                <a:r>
                  <a:rPr lang="en-US" altLang="zh-CN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ultiome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CBA39CE5-038C-490F-1112-E98D53488D97}"/>
                </a:ext>
              </a:extLst>
            </p:cNvPr>
            <p:cNvSpPr txBox="1"/>
            <p:nvPr/>
          </p:nvSpPr>
          <p:spPr>
            <a:xfrm>
              <a:off x="2672631" y="-122351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89C6007-676A-FF8A-FF44-691AEF138C1B}"/>
                </a:ext>
              </a:extLst>
            </p:cNvPr>
            <p:cNvSpPr txBox="1"/>
            <p:nvPr/>
          </p:nvSpPr>
          <p:spPr>
            <a:xfrm>
              <a:off x="2672631" y="131948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59F5BEB-C432-FD1A-BC4E-F5945C36BC95}"/>
                </a:ext>
              </a:extLst>
            </p:cNvPr>
            <p:cNvSpPr txBox="1"/>
            <p:nvPr/>
          </p:nvSpPr>
          <p:spPr>
            <a:xfrm>
              <a:off x="2659807" y="376607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4B7BF8A-9DE3-281C-0FDE-C6AE506C4A44}"/>
                </a:ext>
              </a:extLst>
            </p:cNvPr>
            <p:cNvSpPr txBox="1"/>
            <p:nvPr/>
          </p:nvSpPr>
          <p:spPr>
            <a:xfrm>
              <a:off x="2659807" y="627239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BF5B420B-3865-77C0-8B0F-588D1B28ED3A}"/>
              </a:ext>
            </a:extLst>
          </p:cNvPr>
          <p:cNvSpPr/>
          <p:nvPr/>
        </p:nvSpPr>
        <p:spPr>
          <a:xfrm>
            <a:off x="4782820" y="4401820"/>
            <a:ext cx="378460" cy="88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DACC674-0354-976E-C91A-9F81F3CF8CD6}"/>
              </a:ext>
            </a:extLst>
          </p:cNvPr>
          <p:cNvSpPr txBox="1"/>
          <p:nvPr/>
        </p:nvSpPr>
        <p:spPr>
          <a:xfrm>
            <a:off x="4715815" y="4361631"/>
            <a:ext cx="52770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latin typeface="Arial" panose="020B0604020202020204" pitchFamily="34" charset="0"/>
                <a:cs typeface="Arial" panose="020B0604020202020204" pitchFamily="34" charset="0"/>
              </a:rPr>
              <a:t>MatchCLOT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180B23CE-F47B-F706-8B87-D32745D86021}"/>
              </a:ext>
            </a:extLst>
          </p:cNvPr>
          <p:cNvSpPr/>
          <p:nvPr/>
        </p:nvSpPr>
        <p:spPr>
          <a:xfrm>
            <a:off x="4782820" y="1896342"/>
            <a:ext cx="349250" cy="81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E82C77C-798D-52BD-566C-C6F766E20B6A}"/>
              </a:ext>
            </a:extLst>
          </p:cNvPr>
          <p:cNvSpPr txBox="1"/>
          <p:nvPr/>
        </p:nvSpPr>
        <p:spPr>
          <a:xfrm>
            <a:off x="4712005" y="1852227"/>
            <a:ext cx="52770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latin typeface="Arial" panose="020B0604020202020204" pitchFamily="34" charset="0"/>
                <a:cs typeface="Arial" panose="020B0604020202020204" pitchFamily="34" charset="0"/>
              </a:rPr>
              <a:t>MatchCLOT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B32430F1-203F-0AF7-75FC-989F56D6A185}"/>
              </a:ext>
            </a:extLst>
          </p:cNvPr>
          <p:cNvSpPr/>
          <p:nvPr/>
        </p:nvSpPr>
        <p:spPr>
          <a:xfrm>
            <a:off x="4782820" y="6850994"/>
            <a:ext cx="349250" cy="793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0EA2C15-618A-15C6-6B18-F3356090D24B}"/>
              </a:ext>
            </a:extLst>
          </p:cNvPr>
          <p:cNvSpPr txBox="1"/>
          <p:nvPr/>
        </p:nvSpPr>
        <p:spPr>
          <a:xfrm>
            <a:off x="4715814" y="6806053"/>
            <a:ext cx="52770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latin typeface="Arial" panose="020B0604020202020204" pitchFamily="34" charset="0"/>
                <a:cs typeface="Arial" panose="020B0604020202020204" pitchFamily="34" charset="0"/>
              </a:rPr>
              <a:t>MatchCLOT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788977FF-6098-830B-A6B8-DBDE2283E3A1}"/>
              </a:ext>
            </a:extLst>
          </p:cNvPr>
          <p:cNvSpPr/>
          <p:nvPr/>
        </p:nvSpPr>
        <p:spPr>
          <a:xfrm>
            <a:off x="4805044" y="9330352"/>
            <a:ext cx="349250" cy="793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D347ADA-2BC3-3504-23D5-0D286C4F1255}"/>
              </a:ext>
            </a:extLst>
          </p:cNvPr>
          <p:cNvSpPr txBox="1"/>
          <p:nvPr/>
        </p:nvSpPr>
        <p:spPr>
          <a:xfrm>
            <a:off x="4712004" y="9285411"/>
            <a:ext cx="52770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500" dirty="0" err="1">
                <a:latin typeface="Arial" panose="020B0604020202020204" pitchFamily="34" charset="0"/>
                <a:cs typeface="Arial" panose="020B0604020202020204" pitchFamily="34" charset="0"/>
              </a:rPr>
              <a:t>MatchCLOT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078BE001-EA80-E535-1670-2BEEE33BABE4}"/>
              </a:ext>
            </a:extLst>
          </p:cNvPr>
          <p:cNvGrpSpPr/>
          <p:nvPr/>
        </p:nvGrpSpPr>
        <p:grpSpPr>
          <a:xfrm>
            <a:off x="4930445" y="1568662"/>
            <a:ext cx="442750" cy="169277"/>
            <a:chOff x="4864405" y="2004627"/>
            <a:chExt cx="442750" cy="169277"/>
          </a:xfrm>
        </p:grpSpPr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D2B7FD4-5849-092C-15B6-6AE40A6B3E41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9832AFA-05DE-801C-B8AE-7CDF451EB374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96F627B3-5F9D-0F11-B2B8-5CD8655CAE71}"/>
              </a:ext>
            </a:extLst>
          </p:cNvPr>
          <p:cNvGrpSpPr/>
          <p:nvPr/>
        </p:nvGrpSpPr>
        <p:grpSpPr>
          <a:xfrm>
            <a:off x="4950193" y="1759026"/>
            <a:ext cx="442750" cy="169277"/>
            <a:chOff x="4864405" y="2004627"/>
            <a:chExt cx="442750" cy="169277"/>
          </a:xfrm>
        </p:grpSpPr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C2CD6E21-8681-CF0B-C031-C7F397709F24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5DF0B59-71C4-5B88-D4FD-12A4C5A62506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E63F3566-3A00-CC84-709C-8DC51055E138}"/>
              </a:ext>
            </a:extLst>
          </p:cNvPr>
          <p:cNvGrpSpPr/>
          <p:nvPr/>
        </p:nvGrpSpPr>
        <p:grpSpPr>
          <a:xfrm>
            <a:off x="5041633" y="2044166"/>
            <a:ext cx="442750" cy="169277"/>
            <a:chOff x="4864405" y="2004627"/>
            <a:chExt cx="442750" cy="169277"/>
          </a:xfrm>
        </p:grpSpPr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01ACE5E9-BD34-E395-60D0-5EFA5F945AA7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AFA1B133-7ED4-2AFD-A3B7-BEB2B0F0A9F2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B74C3FB9-929B-FAAB-3D24-9D1B8E93A560}"/>
              </a:ext>
            </a:extLst>
          </p:cNvPr>
          <p:cNvGrpSpPr/>
          <p:nvPr/>
        </p:nvGrpSpPr>
        <p:grpSpPr>
          <a:xfrm>
            <a:off x="5018468" y="2238978"/>
            <a:ext cx="442750" cy="169277"/>
            <a:chOff x="4864405" y="2004627"/>
            <a:chExt cx="442750" cy="169277"/>
          </a:xfrm>
        </p:grpSpPr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3E08AD0A-153F-2A62-3BC8-2AB21C13A394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3CD5CB58-98C7-07A2-4935-C4CB82CED36B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2C90AACF-1A1B-EE8D-6118-F21EC8F346EE}"/>
              </a:ext>
            </a:extLst>
          </p:cNvPr>
          <p:cNvGrpSpPr/>
          <p:nvPr/>
        </p:nvGrpSpPr>
        <p:grpSpPr>
          <a:xfrm>
            <a:off x="4936095" y="4080129"/>
            <a:ext cx="442750" cy="169277"/>
            <a:chOff x="4864405" y="2004627"/>
            <a:chExt cx="442750" cy="169277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34A09F7F-4AE2-B440-7719-D788D7625F9B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C5F1CAD7-826B-CFE9-2D59-73C281F451E7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6FFF9438-AD7C-2D54-F3FF-72F2150D611A}"/>
              </a:ext>
            </a:extLst>
          </p:cNvPr>
          <p:cNvGrpSpPr/>
          <p:nvPr/>
        </p:nvGrpSpPr>
        <p:grpSpPr>
          <a:xfrm>
            <a:off x="4948223" y="4270493"/>
            <a:ext cx="442750" cy="169277"/>
            <a:chOff x="4864405" y="2004627"/>
            <a:chExt cx="442750" cy="169277"/>
          </a:xfrm>
        </p:grpSpPr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A4BAB2BC-1AF4-D62B-0998-4C2F6B607E96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D975BAEE-AB1A-C319-A633-5CCD34A6AA53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510E8629-F009-17C1-259E-55D035581799}"/>
              </a:ext>
            </a:extLst>
          </p:cNvPr>
          <p:cNvGrpSpPr/>
          <p:nvPr/>
        </p:nvGrpSpPr>
        <p:grpSpPr>
          <a:xfrm>
            <a:off x="5041568" y="4553728"/>
            <a:ext cx="442750" cy="169277"/>
            <a:chOff x="4864405" y="2004627"/>
            <a:chExt cx="442750" cy="169277"/>
          </a:xfrm>
        </p:grpSpPr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37406033-E195-8273-4E0D-8B955436C49B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2C61B05-ABCA-1D34-697B-DBF3BF075CC6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067B18DB-734B-4A92-CAF9-CC76F87ACA8C}"/>
              </a:ext>
            </a:extLst>
          </p:cNvPr>
          <p:cNvGrpSpPr/>
          <p:nvPr/>
        </p:nvGrpSpPr>
        <p:grpSpPr>
          <a:xfrm>
            <a:off x="5022213" y="4742825"/>
            <a:ext cx="442750" cy="169277"/>
            <a:chOff x="4864405" y="2004627"/>
            <a:chExt cx="442750" cy="169277"/>
          </a:xfrm>
        </p:grpSpPr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99FE6ACA-98D7-2738-3774-2382864BF415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255F15B1-0D7F-030D-5E0B-4A8B5C53F21B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52F43494-5289-47A0-3F93-BCB5935A0873}"/>
              </a:ext>
            </a:extLst>
          </p:cNvPr>
          <p:cNvGrpSpPr/>
          <p:nvPr/>
        </p:nvGrpSpPr>
        <p:grpSpPr>
          <a:xfrm>
            <a:off x="4936095" y="6525578"/>
            <a:ext cx="442750" cy="169277"/>
            <a:chOff x="4864405" y="2004627"/>
            <a:chExt cx="442750" cy="169277"/>
          </a:xfrm>
        </p:grpSpPr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1C905AA6-1F11-D74B-1688-D5A1191A62F3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7D3F597D-6CF1-109B-9124-0D4756B7FE18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88ABDE10-08CE-26FA-1296-99E9E0839516}"/>
              </a:ext>
            </a:extLst>
          </p:cNvPr>
          <p:cNvGrpSpPr/>
          <p:nvPr/>
        </p:nvGrpSpPr>
        <p:grpSpPr>
          <a:xfrm>
            <a:off x="4948223" y="6715877"/>
            <a:ext cx="442750" cy="169277"/>
            <a:chOff x="4864405" y="2004627"/>
            <a:chExt cx="442750" cy="169277"/>
          </a:xfrm>
        </p:grpSpPr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DD08DF46-C318-8887-E680-342113A1393E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F5AE796C-A08A-7D18-A49F-D9727ADADFAE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0480A7E8-B576-228E-4DB5-F8432F35F0E4}"/>
              </a:ext>
            </a:extLst>
          </p:cNvPr>
          <p:cNvGrpSpPr/>
          <p:nvPr/>
        </p:nvGrpSpPr>
        <p:grpSpPr>
          <a:xfrm>
            <a:off x="5041151" y="6997910"/>
            <a:ext cx="442750" cy="169277"/>
            <a:chOff x="4864405" y="2004627"/>
            <a:chExt cx="442750" cy="169277"/>
          </a:xfrm>
        </p:grpSpPr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F5FDBA38-0454-4491-8DD9-C01D2334133F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B8DC64C8-932B-A889-18E9-8497ABD10B23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1B521364-C776-B8C8-E3C6-A40438A0C88F}"/>
              </a:ext>
            </a:extLst>
          </p:cNvPr>
          <p:cNvGrpSpPr/>
          <p:nvPr/>
        </p:nvGrpSpPr>
        <p:grpSpPr>
          <a:xfrm>
            <a:off x="5018468" y="7194228"/>
            <a:ext cx="442750" cy="169277"/>
            <a:chOff x="4864405" y="2004627"/>
            <a:chExt cx="442750" cy="169277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B498AD86-DD9A-A2BA-7A90-151B0A0B752A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242EA10C-56F5-2FD2-82A8-FFA55300F133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CAC96FB3-D270-8801-EEC2-B677E0B3E113}"/>
              </a:ext>
            </a:extLst>
          </p:cNvPr>
          <p:cNvGrpSpPr/>
          <p:nvPr/>
        </p:nvGrpSpPr>
        <p:grpSpPr>
          <a:xfrm>
            <a:off x="4932350" y="9004768"/>
            <a:ext cx="442750" cy="169277"/>
            <a:chOff x="4864405" y="2004627"/>
            <a:chExt cx="442750" cy="169277"/>
          </a:xfrm>
        </p:grpSpPr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6630A4D7-E5AF-A3C0-99BA-DF7AC07522D1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D5327BBC-4564-11CF-8ABE-7CA2A7DA9154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FCE4E472-671A-2AD7-F94F-4035024BFE3B}"/>
              </a:ext>
            </a:extLst>
          </p:cNvPr>
          <p:cNvGrpSpPr/>
          <p:nvPr/>
        </p:nvGrpSpPr>
        <p:grpSpPr>
          <a:xfrm>
            <a:off x="4944478" y="9195067"/>
            <a:ext cx="442750" cy="169277"/>
            <a:chOff x="4864405" y="2004627"/>
            <a:chExt cx="442750" cy="169277"/>
          </a:xfrm>
        </p:grpSpPr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CB76621B-99B2-79D0-BD83-BDFD656E458F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2E0A0A12-8F57-6F5F-7F42-3A550C778AAB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D7E3DE3C-36F1-EA0C-9550-1C2C2955E838}"/>
              </a:ext>
            </a:extLst>
          </p:cNvPr>
          <p:cNvGrpSpPr/>
          <p:nvPr/>
        </p:nvGrpSpPr>
        <p:grpSpPr>
          <a:xfrm>
            <a:off x="5037406" y="9477100"/>
            <a:ext cx="442750" cy="169277"/>
            <a:chOff x="4864405" y="2004627"/>
            <a:chExt cx="442750" cy="169277"/>
          </a:xfrm>
        </p:grpSpPr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61373DE5-8F53-05DE-F298-18E18679C6CC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03EEC854-980F-1193-2CBC-DEE178E6F3D7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5CAF6979-7315-7AF5-6272-CF735F4FA24E}"/>
              </a:ext>
            </a:extLst>
          </p:cNvPr>
          <p:cNvGrpSpPr/>
          <p:nvPr/>
        </p:nvGrpSpPr>
        <p:grpSpPr>
          <a:xfrm>
            <a:off x="5014723" y="9673418"/>
            <a:ext cx="442750" cy="169277"/>
            <a:chOff x="4864405" y="2004627"/>
            <a:chExt cx="442750" cy="169277"/>
          </a:xfrm>
        </p:grpSpPr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DFC9308C-28E7-03C3-4392-EBF9A6669C0A}"/>
                </a:ext>
              </a:extLst>
            </p:cNvPr>
            <p:cNvSpPr/>
            <p:nvPr/>
          </p:nvSpPr>
          <p:spPr>
            <a:xfrm>
              <a:off x="4935220" y="2048742"/>
              <a:ext cx="349250" cy="81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D0929DD6-08FD-C96D-CF43-106947FBA231}"/>
                </a:ext>
              </a:extLst>
            </p:cNvPr>
            <p:cNvSpPr txBox="1"/>
            <p:nvPr/>
          </p:nvSpPr>
          <p:spPr>
            <a:xfrm>
              <a:off x="4864405" y="2004627"/>
              <a:ext cx="44275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Harmony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7368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40</Words>
  <Application>Microsoft Office PowerPoint</Application>
  <PresentationFormat>自定义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5</cp:revision>
  <dcterms:created xsi:type="dcterms:W3CDTF">2024-12-11T02:27:05Z</dcterms:created>
  <dcterms:modified xsi:type="dcterms:W3CDTF">2025-06-27T07:36:11Z</dcterms:modified>
</cp:coreProperties>
</file>